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57" r:id="rId2"/>
    <p:sldId id="258" r:id="rId3"/>
    <p:sldId id="256" r:id="rId4"/>
    <p:sldId id="259" r:id="rId5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322342F-A10D-5478-CF59-2F024ADEEB0E}" name="Author" initials="Editor" userId="Anonymous_Author" providerId="None"/>
  <p188:author id="{986B6B9F-8F97-FC47-0FFA-F536F2658079}" name="石川　千秋" initials="石川　千秋" userId="S::ishikawac956@naro365.onmicrosoft.com::57355732-6bbf-493a-b736-accf567e578a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uthor" initials="Editor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628002C-119E-4E27-A6A9-26BCBFF0128C}" v="25" dt="2024-04-20T08:14:10.601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2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3102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石川　千秋" userId="57355732-6bbf-493a-b736-accf567e578a" providerId="ADAL" clId="{E628002C-119E-4E27-A6A9-26BCBFF0128C}"/>
    <pc:docChg chg="undo redo custSel addSld modSld">
      <pc:chgData name="石川　千秋" userId="57355732-6bbf-493a-b736-accf567e578a" providerId="ADAL" clId="{E628002C-119E-4E27-A6A9-26BCBFF0128C}" dt="2024-04-20T11:04:08.263" v="803"/>
      <pc:docMkLst>
        <pc:docMk/>
      </pc:docMkLst>
      <pc:sldChg chg="addSp delSp modSp mod delCm modCm">
        <pc:chgData name="石川　千秋" userId="57355732-6bbf-493a-b736-accf567e578a" providerId="ADAL" clId="{E628002C-119E-4E27-A6A9-26BCBFF0128C}" dt="2024-04-20T11:04:08.263" v="803"/>
        <pc:sldMkLst>
          <pc:docMk/>
          <pc:sldMk cId="1608966102" sldId="256"/>
        </pc:sldMkLst>
        <pc:spChg chg="mod">
          <ac:chgData name="石川　千秋" userId="57355732-6bbf-493a-b736-accf567e578a" providerId="ADAL" clId="{E628002C-119E-4E27-A6A9-26BCBFF0128C}" dt="2024-04-20T00:34:02.355" v="631" actId="20577"/>
          <ac:spMkLst>
            <pc:docMk/>
            <pc:sldMk cId="1608966102" sldId="256"/>
            <ac:spMk id="2" creationId="{7879D655-B768-5FAF-8D0E-1E9AD41B2728}"/>
          </ac:spMkLst>
        </pc:spChg>
        <pc:spChg chg="del mod">
          <ac:chgData name="石川　千秋" userId="57355732-6bbf-493a-b736-accf567e578a" providerId="ADAL" clId="{E628002C-119E-4E27-A6A9-26BCBFF0128C}" dt="2024-04-19T17:18:19.769" v="334" actId="21"/>
          <ac:spMkLst>
            <pc:docMk/>
            <pc:sldMk cId="1608966102" sldId="256"/>
            <ac:spMk id="3" creationId="{0127B057-E4D2-8B9A-93B7-D2028776A379}"/>
          </ac:spMkLst>
        </pc:spChg>
        <pc:spChg chg="mod">
          <ac:chgData name="石川　千秋" userId="57355732-6bbf-493a-b736-accf567e578a" providerId="ADAL" clId="{E628002C-119E-4E27-A6A9-26BCBFF0128C}" dt="2024-04-20T00:30:22.244" v="623" actId="1076"/>
          <ac:spMkLst>
            <pc:docMk/>
            <pc:sldMk cId="1608966102" sldId="256"/>
            <ac:spMk id="5" creationId="{455CC3D8-7095-4CD0-AA6B-A326210C34C7}"/>
          </ac:spMkLst>
        </pc:spChg>
        <pc:spChg chg="add del mod">
          <ac:chgData name="石川　千秋" userId="57355732-6bbf-493a-b736-accf567e578a" providerId="ADAL" clId="{E628002C-119E-4E27-A6A9-26BCBFF0128C}" dt="2024-04-19T17:17:56.602" v="324"/>
          <ac:spMkLst>
            <pc:docMk/>
            <pc:sldMk cId="1608966102" sldId="256"/>
            <ac:spMk id="7" creationId="{825102E3-AF2D-8BA8-1FF0-0B1ADF7D07F0}"/>
          </ac:spMkLst>
        </pc:spChg>
        <pc:spChg chg="mod">
          <ac:chgData name="石川　千秋" userId="57355732-6bbf-493a-b736-accf567e578a" providerId="ADAL" clId="{E628002C-119E-4E27-A6A9-26BCBFF0128C}" dt="2024-04-20T00:28:03.914" v="621" actId="1036"/>
          <ac:spMkLst>
            <pc:docMk/>
            <pc:sldMk cId="1608966102" sldId="256"/>
            <ac:spMk id="8" creationId="{D0743D26-D52A-3F47-F068-BDCE99603DFD}"/>
          </ac:spMkLst>
        </pc:spChg>
        <pc:graphicFrameChg chg="add del mod">
          <ac:chgData name="石川　千秋" userId="57355732-6bbf-493a-b736-accf567e578a" providerId="ADAL" clId="{E628002C-119E-4E27-A6A9-26BCBFF0128C}" dt="2024-04-19T23:51:38.450" v="448"/>
          <ac:graphicFrameMkLst>
            <pc:docMk/>
            <pc:sldMk cId="1608966102" sldId="256"/>
            <ac:graphicFrameMk id="3" creationId="{7A48D597-7502-DA71-9F5A-B7B075FA86BC}"/>
          </ac:graphicFrameMkLst>
        </pc:graphicFrameChg>
        <pc:graphicFrameChg chg="mod modGraphic">
          <ac:chgData name="石川　千秋" userId="57355732-6bbf-493a-b736-accf567e578a" providerId="ADAL" clId="{E628002C-119E-4E27-A6A9-26BCBFF0128C}" dt="2024-04-20T08:03:37.316" v="677" actId="20577"/>
          <ac:graphicFrameMkLst>
            <pc:docMk/>
            <pc:sldMk cId="1608966102" sldId="256"/>
            <ac:graphicFrameMk id="4" creationId="{3A96F553-D357-6D12-CBAA-E77E02C5FF05}"/>
          </ac:graphicFrameMkLst>
        </pc:graphicFrameChg>
        <pc:graphicFrameChg chg="add del mod">
          <ac:chgData name="石川　千秋" userId="57355732-6bbf-493a-b736-accf567e578a" providerId="ADAL" clId="{E628002C-119E-4E27-A6A9-26BCBFF0128C}" dt="2024-04-19T17:17:56.602" v="324"/>
          <ac:graphicFrameMkLst>
            <pc:docMk/>
            <pc:sldMk cId="1608966102" sldId="256"/>
            <ac:graphicFrameMk id="6" creationId="{24BABE1D-4BAA-B63A-EE70-6A402805398E}"/>
          </ac:graphicFrameMkLst>
        </pc:graphicFrameChg>
        <pc:extLst>
          <p:ext xmlns:p="http://schemas.openxmlformats.org/presentationml/2006/main" uri="{D6D511B9-2390-475A-947B-AFAB55BFBCF1}">
            <pc226:cmChg xmlns:pc226="http://schemas.microsoft.com/office/powerpoint/2022/06/main/command" chg="del mod">
              <pc226:chgData name="石川　千秋" userId="57355732-6bbf-493a-b736-accf567e578a" providerId="ADAL" clId="{E628002C-119E-4E27-A6A9-26BCBFF0128C}" dt="2024-04-20T11:04:08.263" v="803"/>
              <pc2:cmMkLst xmlns:pc2="http://schemas.microsoft.com/office/powerpoint/2019/9/main/command">
                <pc:docMk/>
                <pc:sldMk cId="1608966102" sldId="256"/>
                <pc2:cmMk id="{859758CA-DAAF-416F-A92E-6713D458FA63}"/>
              </pc2:cmMkLst>
            </pc226:cmChg>
          </p:ext>
        </pc:extLst>
      </pc:sldChg>
      <pc:sldChg chg="addSp delSp modSp mod">
        <pc:chgData name="石川　千秋" userId="57355732-6bbf-493a-b736-accf567e578a" providerId="ADAL" clId="{E628002C-119E-4E27-A6A9-26BCBFF0128C}" dt="2024-04-20T08:14:48.033" v="802" actId="1076"/>
        <pc:sldMkLst>
          <pc:docMk/>
          <pc:sldMk cId="3108015555" sldId="258"/>
        </pc:sldMkLst>
        <pc:spChg chg="mod">
          <ac:chgData name="石川　千秋" userId="57355732-6bbf-493a-b736-accf567e578a" providerId="ADAL" clId="{E628002C-119E-4E27-A6A9-26BCBFF0128C}" dt="2024-04-20T08:14:38.320" v="801"/>
          <ac:spMkLst>
            <pc:docMk/>
            <pc:sldMk cId="3108015555" sldId="258"/>
            <ac:spMk id="2" creationId="{1A833302-2B1D-2D8B-0FDD-F2EC412884C4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4" creationId="{6363E01E-653E-5BC1-224D-3A3BD7E6E975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5" creationId="{EC9DF2DC-6BA9-3F8A-5BCB-2AC9B01D9BD4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6" creationId="{419BA0E7-6B04-5B00-B7BD-156F27997642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7" creationId="{18A719BE-1E1B-856E-537E-9D7E1C5AA8EA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8" creationId="{3983931F-F1C0-A6DB-E141-324557B4CFEA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9" creationId="{DD78528D-D4DB-F188-135A-B36F88A9298E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10" creationId="{49D5A85F-C978-7333-746C-8A5BE6FEEFD0}"/>
          </ac:spMkLst>
        </pc:spChg>
        <pc:spChg chg="add del mod">
          <ac:chgData name="石川　千秋" userId="57355732-6bbf-493a-b736-accf567e578a" providerId="ADAL" clId="{E628002C-119E-4E27-A6A9-26BCBFF0128C}" dt="2024-04-20T08:14:48.033" v="802" actId="1076"/>
          <ac:spMkLst>
            <pc:docMk/>
            <pc:sldMk cId="3108015555" sldId="258"/>
            <ac:spMk id="11" creationId="{AF2FA357-FF79-A231-B450-18B5801D8EE1}"/>
          </ac:spMkLst>
        </pc:spChg>
        <pc:spChg chg="del mod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26" creationId="{ECDBD584-3449-D8A7-8F26-CA7ACB3B5655}"/>
          </ac:spMkLst>
        </pc:spChg>
        <pc:spChg chg="del mod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28" creationId="{36CE8BEE-D3CE-4D8F-B835-021DD3D6D6CC}"/>
          </ac:spMkLst>
        </pc:spChg>
        <pc:spChg chg="del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29" creationId="{6ABBD8F3-C8F2-8C87-9B95-BEC869A8E011}"/>
          </ac:spMkLst>
        </pc:spChg>
        <pc:spChg chg="del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30" creationId="{3E6C1FFB-C942-A226-745D-6465907364F0}"/>
          </ac:spMkLst>
        </pc:spChg>
        <pc:spChg chg="del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31" creationId="{37ABA24A-BE2B-AF81-17DD-9BBF83868829}"/>
          </ac:spMkLst>
        </pc:spChg>
        <pc:spChg chg="del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32" creationId="{1A2BBC95-8F14-52B8-971E-DCCB0D2C08B6}"/>
          </ac:spMkLst>
        </pc:spChg>
        <pc:spChg chg="del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33" creationId="{AC671545-2EA1-72B5-7226-3DF6493BAA5B}"/>
          </ac:spMkLst>
        </pc:spChg>
        <pc:spChg chg="del">
          <ac:chgData name="石川　千秋" userId="57355732-6bbf-493a-b736-accf567e578a" providerId="ADAL" clId="{E628002C-119E-4E27-A6A9-26BCBFF0128C}" dt="2024-04-19T08:22:53.768" v="143" actId="478"/>
          <ac:spMkLst>
            <pc:docMk/>
            <pc:sldMk cId="3108015555" sldId="258"/>
            <ac:spMk id="34" creationId="{1E93EB7D-E63A-F957-2790-169770B2DCE3}"/>
          </ac:spMkLst>
        </pc:spChg>
        <pc:graphicFrameChg chg="add del mod">
          <ac:chgData name="石川　千秋" userId="57355732-6bbf-493a-b736-accf567e578a" providerId="ADAL" clId="{E628002C-119E-4E27-A6A9-26BCBFF0128C}" dt="2024-04-20T08:14:48.033" v="802" actId="1076"/>
          <ac:graphicFrameMkLst>
            <pc:docMk/>
            <pc:sldMk cId="3108015555" sldId="258"/>
            <ac:graphicFrameMk id="3" creationId="{36E170B5-5746-94C1-D0A9-E234FE95B2BD}"/>
          </ac:graphicFrameMkLst>
        </pc:graphicFrameChg>
        <pc:graphicFrameChg chg="del mod">
          <ac:chgData name="石川　千秋" userId="57355732-6bbf-493a-b736-accf567e578a" providerId="ADAL" clId="{E628002C-119E-4E27-A6A9-26BCBFF0128C}" dt="2024-04-19T08:22:53.768" v="143" actId="478"/>
          <ac:graphicFrameMkLst>
            <pc:docMk/>
            <pc:sldMk cId="3108015555" sldId="258"/>
            <ac:graphicFrameMk id="18" creationId="{F0D93E1D-8551-36E7-AF3D-196F30A997AA}"/>
          </ac:graphicFrameMkLst>
        </pc:graphicFrameChg>
        <pc:picChg chg="add del mod">
          <ac:chgData name="石川　千秋" userId="57355732-6bbf-493a-b736-accf567e578a" providerId="ADAL" clId="{E628002C-119E-4E27-A6A9-26BCBFF0128C}" dt="2024-04-19T08:28:27.711" v="169"/>
          <ac:picMkLst>
            <pc:docMk/>
            <pc:sldMk cId="3108015555" sldId="258"/>
            <ac:picMk id="12" creationId="{0C300C76-A7A3-23E6-2CAE-F9BC3A59C905}"/>
          </ac:picMkLst>
        </pc:picChg>
      </pc:sldChg>
      <pc:sldChg chg="addSp modSp new mod">
        <pc:chgData name="石川　千秋" userId="57355732-6bbf-493a-b736-accf567e578a" providerId="ADAL" clId="{E628002C-119E-4E27-A6A9-26BCBFF0128C}" dt="2024-04-19T17:18:35.294" v="338" actId="1076"/>
        <pc:sldMkLst>
          <pc:docMk/>
          <pc:sldMk cId="3885266715" sldId="259"/>
        </pc:sldMkLst>
        <pc:spChg chg="add mod">
          <ac:chgData name="石川　千秋" userId="57355732-6bbf-493a-b736-accf567e578a" providerId="ADAL" clId="{E628002C-119E-4E27-A6A9-26BCBFF0128C}" dt="2024-04-19T17:18:35.294" v="338" actId="1076"/>
          <ac:spMkLst>
            <pc:docMk/>
            <pc:sldMk cId="3885266715" sldId="259"/>
            <ac:spMk id="2" creationId="{960BBB77-4016-5E81-3027-A50831EBC369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12946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371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9568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43352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322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6119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41852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19001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9160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16676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47516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6E13E0-4F2D-4407-AF28-36285EA9A5B6}" type="datetimeFigureOut">
              <a:rPr kumimoji="1" lang="ja-JP" altLang="en-US" smtClean="0"/>
              <a:t>2024/4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D4BECC-6656-411B-A0AF-219A32A760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53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DB820E9C-7B79-CAF2-9B6D-9E51414259F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50367736"/>
              </p:ext>
            </p:extLst>
          </p:nvPr>
        </p:nvGraphicFramePr>
        <p:xfrm>
          <a:off x="0" y="369332"/>
          <a:ext cx="6858001" cy="6259295"/>
        </p:xfrm>
        <a:graphic>
          <a:graphicData uri="http://schemas.openxmlformats.org/drawingml/2006/table">
            <a:tbl>
              <a:tblPr/>
              <a:tblGrid>
                <a:gridCol w="652856">
                  <a:extLst>
                    <a:ext uri="{9D8B030D-6E8A-4147-A177-3AD203B41FA5}">
                      <a16:colId xmlns:a16="http://schemas.microsoft.com/office/drawing/2014/main" val="3945920847"/>
                    </a:ext>
                  </a:extLst>
                </a:gridCol>
                <a:gridCol w="894653">
                  <a:extLst>
                    <a:ext uri="{9D8B030D-6E8A-4147-A177-3AD203B41FA5}">
                      <a16:colId xmlns:a16="http://schemas.microsoft.com/office/drawing/2014/main" val="1051399163"/>
                    </a:ext>
                  </a:extLst>
                </a:gridCol>
                <a:gridCol w="1329890">
                  <a:extLst>
                    <a:ext uri="{9D8B030D-6E8A-4147-A177-3AD203B41FA5}">
                      <a16:colId xmlns:a16="http://schemas.microsoft.com/office/drawing/2014/main" val="947733115"/>
                    </a:ext>
                  </a:extLst>
                </a:gridCol>
                <a:gridCol w="1354070">
                  <a:extLst>
                    <a:ext uri="{9D8B030D-6E8A-4147-A177-3AD203B41FA5}">
                      <a16:colId xmlns:a16="http://schemas.microsoft.com/office/drawing/2014/main" val="1551178698"/>
                    </a:ext>
                  </a:extLst>
                </a:gridCol>
                <a:gridCol w="1402429">
                  <a:extLst>
                    <a:ext uri="{9D8B030D-6E8A-4147-A177-3AD203B41FA5}">
                      <a16:colId xmlns:a16="http://schemas.microsoft.com/office/drawing/2014/main" val="3376917121"/>
                    </a:ext>
                  </a:extLst>
                </a:gridCol>
                <a:gridCol w="1224103">
                  <a:extLst>
                    <a:ext uri="{9D8B030D-6E8A-4147-A177-3AD203B41FA5}">
                      <a16:colId xmlns:a16="http://schemas.microsoft.com/office/drawing/2014/main" val="1169420132"/>
                    </a:ext>
                  </a:extLst>
                </a:gridCol>
              </a:tblGrid>
              <a:tr h="489007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ultivar or clone 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am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aren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900" b="0" i="0" u="none" strike="noStrike" dirty="0">
                        <a:solidFill>
                          <a:srgbClr val="000000"/>
                        </a:solidFill>
                        <a:effectLst/>
                        <a:latin typeface="游ゴシック" panose="020B0400000000000000" pitchFamily="50" charset="-128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Year of application </a:t>
                      </a:r>
                      <a:b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or cultivar registration</a:t>
                      </a:r>
                    </a:p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in Japa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Year of registration</a:t>
                      </a:r>
                      <a:b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 Japa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4835310"/>
                  </a:ext>
                </a:extLst>
              </a:tr>
              <a:tr h="48900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Femal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0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Mal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5947810"/>
                  </a:ext>
                </a:extLst>
              </a:tr>
              <a:tr h="195603">
                <a:tc rowSpan="6"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tandard</a:t>
                      </a:r>
                      <a:b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ultiva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Co31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o42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o31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73134540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P57-61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16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99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99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2887828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F81-3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OC1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0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0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2057193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2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F89-6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Open (unknown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0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0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36623375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Tn03-5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OC1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P57-61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96473158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arunoog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Fo93-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2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66380018"/>
                  </a:ext>
                </a:extLst>
              </a:tr>
              <a:tr h="195603">
                <a:tc rowSpan="21"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lo</a:t>
                      </a:r>
                      <a:r>
                        <a:rPr lang="en-US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05-6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92-13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F92-3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8466695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0-106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19821457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0T-53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ineX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57271808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1-65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01-204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9630402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102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K99-14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2956320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119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K99-14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1509052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12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K99-14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DCE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668413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83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00-15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N00-11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9779679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2-15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K04-1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6717489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2-25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2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04781463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2-31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2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9091749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54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9449637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55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03139832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67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05051340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70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6029557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8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06-19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K94-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59353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9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61-4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6604829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T-50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9208815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T-50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K99-14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N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CFF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1045776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T-505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E69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ineX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4980406"/>
                  </a:ext>
                </a:extLst>
              </a:tr>
              <a:tr h="195603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3-13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2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DEBF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9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1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9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Palatino Linotype" panose="02040502050505030304" pitchFamily="18" charset="0"/>
                          <a:ea typeface="游ゴシック" panose="020B0400000000000000" pitchFamily="50" charset="-128"/>
                          <a:cs typeface="+mn-cs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3882355"/>
                  </a:ext>
                </a:extLst>
              </a:tr>
            </a:tbl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A86A6DF-F52D-58FD-C4A3-A02FBC906D96}"/>
              </a:ext>
            </a:extLst>
          </p:cNvPr>
          <p:cNvSpPr txBox="1"/>
          <p:nvPr/>
        </p:nvSpPr>
        <p:spPr>
          <a:xfrm>
            <a:off x="0" y="0"/>
            <a:ext cx="6858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Palatino Linotype" panose="02040502050505030304" pitchFamily="18" charset="0"/>
              </a:rPr>
              <a:t>Table S1.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Crossbreeding information about sampled cultivars and clones. Hyphen (-) indicates not registered or under selection during 2018–2020. Same cultivars or clones are filled in the similar colors.</a:t>
            </a:r>
          </a:p>
        </p:txBody>
      </p:sp>
    </p:spTree>
    <p:extLst>
      <p:ext uri="{BB962C8B-B14F-4D97-AF65-F5344CB8AC3E}">
        <p14:creationId xmlns:p14="http://schemas.microsoft.com/office/powerpoint/2010/main" val="416763707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A833302-2B1D-2D8B-0FDD-F2EC412884C4}"/>
              </a:ext>
            </a:extLst>
          </p:cNvPr>
          <p:cNvSpPr txBox="1"/>
          <p:nvPr/>
        </p:nvSpPr>
        <p:spPr>
          <a:xfrm>
            <a:off x="1187" y="501"/>
            <a:ext cx="68580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Palatino Linotype" panose="02040502050505030304" pitchFamily="18" charset="0"/>
              </a:rPr>
              <a:t>Table S2.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Number of samples for each cultivar and clones, cropping types by</a:t>
            </a:r>
            <a:r>
              <a:rPr kumimoji="1" lang="ja-JP" altLang="en-US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year. Overall, </a:t>
            </a:r>
            <a:r>
              <a:rPr lang="en-US" altLang="ja-JP" sz="900" dirty="0">
                <a:latin typeface="Palatino Linotype" panose="02040502050505030304" pitchFamily="18" charset="0"/>
              </a:rPr>
              <a:t>224 plots were</a:t>
            </a:r>
            <a:r>
              <a:rPr lang="en-US" altLang="ja-JP" sz="900" dirty="0">
                <a:solidFill>
                  <a:srgbClr val="FF0000"/>
                </a:solidFill>
                <a:latin typeface="Palatino Linotype" panose="02040502050505030304" pitchFamily="18" charset="0"/>
              </a:rPr>
              <a:t> </a:t>
            </a:r>
            <a:r>
              <a:rPr lang="en-US" altLang="ja-JP" sz="900" dirty="0">
                <a:latin typeface="Palatino Linotype" panose="02040502050505030304" pitchFamily="18" charset="0"/>
              </a:rPr>
              <a:t>harvested in 2018 (1st ratoon: 86, 2nd ratoon: 51, new planting: 87), 174 plots in 2019 (1st ratoon: 60, 2nd ratoon: 54, new planting: 60), and 66 plots in 2020 (1st ratoon: 24, 2nd ratoon: 18, new planting: 24). One asterisk (*) marks one plots of KY11-1199 (2nd ratoon in 2018) were missing concentration data for asparagine</a:t>
            </a:r>
            <a:r>
              <a:rPr lang="ja-JP" altLang="en-US" sz="900" dirty="0">
                <a:latin typeface="Palatino Linotype" panose="02040502050505030304" pitchFamily="18" charset="0"/>
              </a:rPr>
              <a:t> </a:t>
            </a:r>
            <a:r>
              <a:rPr lang="en-US" altLang="ja-JP" sz="900" dirty="0">
                <a:latin typeface="Palatino Linotype" panose="02040502050505030304" pitchFamily="18" charset="0"/>
              </a:rPr>
              <a:t>and glutamate because of peak separation failure. Two asterisks (**) mark one plot of KY10T-531 (2nd ratoon in 2018) that was missing concentration data for arginine because of measurement failure. One asterisk (*) and two asterisks (**) mark indicate missing data regarding the concentration of total amino acids. Three asterisks (***) mark one plot each for four cultivars that were missing values of millable stalk lengths (new planting: KR12-251, 1st ratoon: KY12-544, KY12-671, KY12-872 in 2019).</a:t>
            </a: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36E170B5-5746-94C1-D0A9-E234FE95B2B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59218819"/>
              </p:ext>
            </p:extLst>
          </p:nvPr>
        </p:nvGraphicFramePr>
        <p:xfrm>
          <a:off x="0" y="1200830"/>
          <a:ext cx="6854163" cy="3939913"/>
        </p:xfrm>
        <a:graphic>
          <a:graphicData uri="http://schemas.openxmlformats.org/drawingml/2006/table">
            <a:tbl>
              <a:tblPr/>
              <a:tblGrid>
                <a:gridCol w="607039">
                  <a:extLst>
                    <a:ext uri="{9D8B030D-6E8A-4147-A177-3AD203B41FA5}">
                      <a16:colId xmlns:a16="http://schemas.microsoft.com/office/drawing/2014/main" val="666383833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1643022711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1048091982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388758014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63690213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1321024770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1218402095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115441623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35613451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72879152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679140086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667963722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161051168"/>
                    </a:ext>
                  </a:extLst>
                </a:gridCol>
                <a:gridCol w="480548">
                  <a:extLst>
                    <a:ext uri="{9D8B030D-6E8A-4147-A177-3AD203B41FA5}">
                      <a16:colId xmlns:a16="http://schemas.microsoft.com/office/drawing/2014/main" val="2928323869"/>
                    </a:ext>
                  </a:extLst>
                </a:gridCol>
              </a:tblGrid>
              <a:tr h="1252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Year</a:t>
                      </a:r>
                      <a:endParaRPr 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02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83121461"/>
                  </a:ext>
                </a:extLst>
              </a:tr>
              <a:tr h="432000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lToBr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ew planting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st Rato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nd Rato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ubtota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ew planting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st Rato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nd Rato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</a:t>
                      </a:r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ubtota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ew planting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st Rato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nd Rato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ubtota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91149993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05-6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5003148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1-65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5625354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2-15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22871723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2-25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01853528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2-31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62465291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R13-13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05799621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0-106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94633598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0T-53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en-US" altLang="ja-JP" sz="700" b="0" i="0" u="none" strike="noStrike" baseline="0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75614702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102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02961801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119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28428916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12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1274594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1-83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91859898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54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21017573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55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19117202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67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88406378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70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20736540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87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0160945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-91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  <a:endParaRPr lang="ja-JP" altLang="en-US" sz="700" b="0" i="0" u="none" strike="noStrike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0228262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T-500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06038974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T-50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4361407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Y12T-505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86924200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Tn03-5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64590505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Co31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61159460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22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51873811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F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7495783"/>
                  </a:ext>
                </a:extLst>
              </a:tr>
              <a:tr h="12046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iTn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31492334"/>
                  </a:ext>
                </a:extLst>
              </a:tr>
              <a:tr h="1252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arunoogi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3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9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699303"/>
                  </a:ext>
                </a:extLst>
              </a:tr>
              <a:tr h="12528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ota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87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8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1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0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5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7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18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66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464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09384803"/>
                  </a:ext>
                </a:extLst>
              </a:tr>
            </a:tbl>
          </a:graphicData>
        </a:graphic>
      </p:graphicFrame>
      <p:sp>
        <p:nvSpPr>
          <p:cNvPr id="4" name="テキスト ボックス 8">
            <a:extLst>
              <a:ext uri="{FF2B5EF4-FFF2-40B4-BE49-F238E27FC236}">
                <a16:creationId xmlns:a16="http://schemas.microsoft.com/office/drawing/2014/main" id="{6363E01E-653E-5BC1-224D-3A3BD7E6E975}"/>
              </a:ext>
            </a:extLst>
          </p:cNvPr>
          <p:cNvSpPr txBox="1"/>
          <p:nvPr/>
        </p:nvSpPr>
        <p:spPr>
          <a:xfrm>
            <a:off x="-64184" y="1508449"/>
            <a:ext cx="723900" cy="285206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kumimoji="1" lang="en-US" altLang="ja-JP" sz="700" b="1" dirty="0">
                <a:latin typeface="Palatino Linotype" panose="02040502050505030304" pitchFamily="18" charset="0"/>
              </a:rPr>
              <a:t>Cultivar</a:t>
            </a:r>
          </a:p>
          <a:p>
            <a:r>
              <a:rPr kumimoji="1" lang="en-US" altLang="ja-JP" sz="700" b="1" dirty="0">
                <a:latin typeface="Palatino Linotype" panose="02040502050505030304" pitchFamily="18" charset="0"/>
              </a:rPr>
              <a:t>or clone</a:t>
            </a:r>
            <a:endParaRPr kumimoji="1" lang="ja-JP" altLang="en-US" sz="700" b="1" dirty="0">
              <a:latin typeface="Palatino Linotype" panose="02040502050505030304" pitchFamily="18" charset="0"/>
            </a:endParaRPr>
          </a:p>
        </p:txBody>
      </p:sp>
      <p:sp>
        <p:nvSpPr>
          <p:cNvPr id="5" name="テキスト ボックス 10">
            <a:extLst>
              <a:ext uri="{FF2B5EF4-FFF2-40B4-BE49-F238E27FC236}">
                <a16:creationId xmlns:a16="http://schemas.microsoft.com/office/drawing/2014/main" id="{EC9DF2DC-6BA9-3F8A-5BCB-2AC9B01D9BD4}"/>
              </a:ext>
            </a:extLst>
          </p:cNvPr>
          <p:cNvSpPr txBox="1"/>
          <p:nvPr/>
        </p:nvSpPr>
        <p:spPr>
          <a:xfrm>
            <a:off x="-85286" y="1298801"/>
            <a:ext cx="759509" cy="285207"/>
          </a:xfrm>
          <a:prstGeom prst="rect">
            <a:avLst/>
          </a:prstGeom>
          <a:noFill/>
          <a:ln w="9525" cmpd="sng">
            <a:noFill/>
          </a:ln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dk1"/>
          </a:fontRef>
        </p:style>
        <p:txBody>
          <a:bodyPr wrap="square" rtlCol="0" anchor="t"/>
          <a:lstStyle>
            <a:lvl1pPr marL="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>
              <a:lnSpc>
                <a:spcPts val="700"/>
              </a:lnSpc>
            </a:pPr>
            <a:r>
              <a:rPr kumimoji="1" lang="en-US" altLang="ja-JP" sz="700" b="1" dirty="0">
                <a:latin typeface="Palatino Linotype" panose="02040502050505030304" pitchFamily="18" charset="0"/>
              </a:rPr>
              <a:t>Cropping</a:t>
            </a:r>
          </a:p>
          <a:p>
            <a:pPr algn="r">
              <a:lnSpc>
                <a:spcPts val="700"/>
              </a:lnSpc>
            </a:pPr>
            <a:r>
              <a:rPr kumimoji="1" lang="en-US" altLang="ja-JP" sz="700" b="1" dirty="0">
                <a:latin typeface="Palatino Linotype" panose="02040502050505030304" pitchFamily="18" charset="0"/>
              </a:rPr>
              <a:t>type</a:t>
            </a:r>
            <a:endParaRPr kumimoji="1" lang="ja-JP" altLang="en-US" sz="700" b="1" dirty="0">
              <a:latin typeface="Palatino Linotype" panose="02040502050505030304" pitchFamily="18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419BA0E7-6B04-5B00-B7BD-156F27997642}"/>
              </a:ext>
            </a:extLst>
          </p:cNvPr>
          <p:cNvSpPr txBox="1"/>
          <p:nvPr/>
        </p:nvSpPr>
        <p:spPr>
          <a:xfrm>
            <a:off x="1742032" y="2544183"/>
            <a:ext cx="25519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Palatino Linotype" panose="02040502050505030304" pitchFamily="18" charset="0"/>
              </a:rPr>
              <a:t>**</a:t>
            </a:r>
            <a:endParaRPr kumimoji="1" lang="ja-JP" altLang="en-US" sz="700" dirty="0">
              <a:latin typeface="Palatino Linotype" panose="0204050205050503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18A719BE-1E1B-856E-537E-9D7E1C5AA8EA}"/>
              </a:ext>
            </a:extLst>
          </p:cNvPr>
          <p:cNvSpPr txBox="1"/>
          <p:nvPr/>
        </p:nvSpPr>
        <p:spPr>
          <a:xfrm>
            <a:off x="1742032" y="2783244"/>
            <a:ext cx="2199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Palatino Linotype" panose="02040502050505030304" pitchFamily="18" charset="0"/>
              </a:rPr>
              <a:t>*</a:t>
            </a:r>
            <a:endParaRPr kumimoji="1" lang="ja-JP" altLang="en-US" sz="700" dirty="0">
              <a:latin typeface="Palatino Linotype" panose="0204050205050503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983931F-F1C0-A6DB-E141-324557B4CFEA}"/>
              </a:ext>
            </a:extLst>
          </p:cNvPr>
          <p:cNvSpPr txBox="1"/>
          <p:nvPr/>
        </p:nvSpPr>
        <p:spPr>
          <a:xfrm>
            <a:off x="2702395" y="2059949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Palatino Linotype" panose="02040502050505030304" pitchFamily="18" charset="0"/>
              </a:rPr>
              <a:t>***</a:t>
            </a:r>
            <a:endParaRPr kumimoji="1" lang="ja-JP" altLang="en-US" sz="700" dirty="0">
              <a:latin typeface="Palatino Linotype" panose="0204050205050503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DD78528D-D4DB-F188-135A-B36F88A9298E}"/>
              </a:ext>
            </a:extLst>
          </p:cNvPr>
          <p:cNvSpPr txBox="1"/>
          <p:nvPr/>
        </p:nvSpPr>
        <p:spPr>
          <a:xfrm>
            <a:off x="3184193" y="3151491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Palatino Linotype" panose="02040502050505030304" pitchFamily="18" charset="0"/>
              </a:rPr>
              <a:t>***</a:t>
            </a:r>
            <a:endParaRPr kumimoji="1" lang="ja-JP" altLang="en-US" sz="700" dirty="0">
              <a:latin typeface="Palatino Linotype" panose="0204050205050503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9D5A85F-C978-7333-746C-8A5BE6FEEFD0}"/>
              </a:ext>
            </a:extLst>
          </p:cNvPr>
          <p:cNvSpPr txBox="1"/>
          <p:nvPr/>
        </p:nvSpPr>
        <p:spPr>
          <a:xfrm>
            <a:off x="3184193" y="3389302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Palatino Linotype" panose="02040502050505030304" pitchFamily="18" charset="0"/>
              </a:rPr>
              <a:t>***</a:t>
            </a:r>
            <a:endParaRPr kumimoji="1" lang="ja-JP" altLang="en-US" sz="700" dirty="0">
              <a:latin typeface="Palatino Linotype" panose="0204050205050503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AF2FA357-FF79-A231-B450-18B5801D8EE1}"/>
              </a:ext>
            </a:extLst>
          </p:cNvPr>
          <p:cNvSpPr txBox="1"/>
          <p:nvPr/>
        </p:nvSpPr>
        <p:spPr>
          <a:xfrm>
            <a:off x="3184193" y="3627113"/>
            <a:ext cx="2904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dirty="0">
                <a:latin typeface="Palatino Linotype" panose="02040502050505030304" pitchFamily="18" charset="0"/>
              </a:rPr>
              <a:t>***</a:t>
            </a:r>
            <a:endParaRPr kumimoji="1" lang="ja-JP" altLang="en-US" sz="7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80155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3A96F553-D357-6D12-CBAA-E77E02C5FF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25163988"/>
              </p:ext>
            </p:extLst>
          </p:nvPr>
        </p:nvGraphicFramePr>
        <p:xfrm>
          <a:off x="0" y="1073861"/>
          <a:ext cx="6858000" cy="7553806"/>
        </p:xfrm>
        <a:graphic>
          <a:graphicData uri="http://schemas.openxmlformats.org/drawingml/2006/table">
            <a:tbl>
              <a:tblPr/>
              <a:tblGrid>
                <a:gridCol w="752559">
                  <a:extLst>
                    <a:ext uri="{9D8B030D-6E8A-4147-A177-3AD203B41FA5}">
                      <a16:colId xmlns:a16="http://schemas.microsoft.com/office/drawing/2014/main" val="3035301807"/>
                    </a:ext>
                  </a:extLst>
                </a:gridCol>
                <a:gridCol w="1015951">
                  <a:extLst>
                    <a:ext uri="{9D8B030D-6E8A-4147-A177-3AD203B41FA5}">
                      <a16:colId xmlns:a16="http://schemas.microsoft.com/office/drawing/2014/main" val="2407198833"/>
                    </a:ext>
                  </a:extLst>
                </a:gridCol>
                <a:gridCol w="226088">
                  <a:extLst>
                    <a:ext uri="{9D8B030D-6E8A-4147-A177-3AD203B41FA5}">
                      <a16:colId xmlns:a16="http://schemas.microsoft.com/office/drawing/2014/main" val="3402020186"/>
                    </a:ext>
                  </a:extLst>
                </a:gridCol>
                <a:gridCol w="572756">
                  <a:extLst>
                    <a:ext uri="{9D8B030D-6E8A-4147-A177-3AD203B41FA5}">
                      <a16:colId xmlns:a16="http://schemas.microsoft.com/office/drawing/2014/main" val="716605451"/>
                    </a:ext>
                  </a:extLst>
                </a:gridCol>
                <a:gridCol w="414144">
                  <a:extLst>
                    <a:ext uri="{9D8B030D-6E8A-4147-A177-3AD203B41FA5}">
                      <a16:colId xmlns:a16="http://schemas.microsoft.com/office/drawing/2014/main" val="2971175348"/>
                    </a:ext>
                  </a:extLst>
                </a:gridCol>
                <a:gridCol w="3876502">
                  <a:extLst>
                    <a:ext uri="{9D8B030D-6E8A-4147-A177-3AD203B41FA5}">
                      <a16:colId xmlns:a16="http://schemas.microsoft.com/office/drawing/2014/main" val="978548777"/>
                    </a:ext>
                  </a:extLst>
                </a:gridCol>
              </a:tblGrid>
              <a:tr h="252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ategory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aramete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Uni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vestigation </a:t>
                      </a:r>
                      <a:b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7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objec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xclusion</a:t>
                      </a:r>
                      <a:b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by test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1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efiniti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49810906"/>
                  </a:ext>
                </a:extLst>
              </a:tr>
              <a:tr h="252000">
                <a:tc rowSpan="12"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ost-harvest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EFDA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arveste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alive stalks included dead, broken stalks without weak stalks in harveste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5400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6554976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millable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healthy millable or alive stalks and broken stalks ≥ 1m</a:t>
                      </a:r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</a:t>
                      </a:r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length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xcluding weak</a:t>
                      </a:r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or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dea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59457460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oken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broken stalks in harveste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4666721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ea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stalks with dead parts in harveste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04663132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weak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live stalks &gt; 30 cm and &lt; 1m in length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83350947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Length of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millable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length of stalks without sugarcane top  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4061305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iameter of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millable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of minor axes which are orthogonal to major axes connecting budding positions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on the central internode of the middle of millable-stalk removed cane top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99204811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internodes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per stal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stal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number of internodes per stalk from 10 millable stalks as a representative sample of experimental plot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2852426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cracked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internodes per stal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stal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number of cracked internodes per stalk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8001486"/>
                  </a:ext>
                </a:extLst>
              </a:tr>
              <a:tr h="54758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Weight of cane top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g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“Cane top” is defined as from the top of the stem to the base of the 5th youngest fully-extended leaf (or 5th visible dewlap leaf) from the top on a non-heading stalk, to the 9th youngest fully-extended leaf on the heading stalk, to the 7th youngest fully-extended leaf on booting stalks. </a:t>
                      </a:r>
                      <a:b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he weight of green leaves and tops is calculated from the cane top weight of 10 </a:t>
                      </a:r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illable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stalks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as a representative sample.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9097212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Weight of millable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g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*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otal weight of all stalks counted as millable stalks, excluding cane top and leaves</a:t>
                      </a:r>
                    </a:p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* Calculated from the sampling survey in the fourth selecti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61082356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Weight per stalk 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*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Quotient of weight of millable stalks by number of </a:t>
                      </a:r>
                      <a:r>
                        <a:rPr lang="en-US" sz="700" b="0" i="0" u="none" strike="noStrike" dirty="0" err="1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millable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stalks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* Calculated from the sampling survey in the fourth selecti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89468243"/>
                  </a:ext>
                </a:extLst>
              </a:tr>
              <a:tr h="252000">
                <a:tc rowSpan="4"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ost-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ompression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ＭＳ Ｐゴシック" panose="020B0600070205080204" pitchFamily="50" charset="-128"/>
                        </a:rPr>
                        <a:t>　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experiment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2CC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ix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ercentage of total soluble solids in sugarcane juice measured using a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digital refractometer (RX-5000, </a:t>
                      </a:r>
                      <a:r>
                        <a:rPr lang="pl-PL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tago Co., Ltd., Tokyo, Japan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) converted at 2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0˚C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6686755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ternational sugar scale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Z˚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Value measured and calculated with an automatic polarimeter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(Sucromat MCP200, Anton-Paar Japan K.K., Tokyo, Japan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35957596"/>
                  </a:ext>
                </a:extLst>
              </a:tr>
              <a:tr h="54758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Fibe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36000"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Weight percentage of insoluble structural characteristic carbohydrate in stalks</a:t>
                      </a:r>
                      <a:b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6602853"/>
                  </a:ext>
                </a:extLst>
              </a:tr>
              <a:tr h="216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ommercial cane suga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Weight percentage of theoretically obtainable sucrose from millable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36942372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omplex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Yield of estimated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ailable suga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kg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-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Product of weight of millable stalks and commercial cane sugar per cultivated are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6849820"/>
                  </a:ext>
                </a:extLst>
              </a:tr>
              <a:tr h="252000">
                <a:tc rowSpan="8"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Growth</a:t>
                      </a: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E4D6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sprouts from ratoon stool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sprouts from ratoon stool counted before first top-dressing in spring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(from end of March to April) per cultivated are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47147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ate of sprouts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to harveste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ate of sprouts to harvested stalks in the last year at the same experimental plot in spring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(from end of March to April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85948818"/>
                  </a:ext>
                </a:extLst>
              </a:tr>
              <a:tr h="234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itial number of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stalks per cultivated area in an experimental plot 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at early growth phase (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 July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79820839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itial height of</a:t>
                      </a:r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of stalk heights 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(from the edge of the ground to the base of the top visible dewlap leaf)</a:t>
                      </a:r>
                    </a:p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at early growth stage (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 July)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82958211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ber of stalks in autum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/a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‡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Num</a:t>
                      </a: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er of stalks per cultivated area at an experimental plot in Octobe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04447184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Height of stalks in autum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cm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of stalk heights </a:t>
                      </a: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(from the edge of the ground to the base of the top visible dewlap leaf) in October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73032021"/>
                  </a:ext>
                </a:extLst>
              </a:tr>
              <a:tr h="547587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ix </a:t>
                      </a:r>
                      <a:r>
                        <a:rPr lang="en-US" sz="700" b="0" i="0" u="none" strike="noStrike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in autumn</a:t>
                      </a:r>
                      <a:endParaRPr lang="en-US" sz="7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*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verage Brix of drops of sugarcane juice at the central part of the upper, middle, and lower nodes of part of sugarcane, excluding the cane top, measured by a handy reflectometer (MASTER-P</a:t>
                      </a:r>
                      <a:r>
                        <a:rPr lang="el-GR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α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, </a:t>
                      </a:r>
                      <a:r>
                        <a:rPr lang="pl-PL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Atago Co., Ltd., Tokyo, Japan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 or SK-100R, Sato Keiryoki Mfg. Co., Ltd., Tokyo, Japan</a:t>
                      </a:r>
                      <a:r>
                        <a:rPr lang="en-US" altLang="ja-JP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)</a:t>
                      </a:r>
                      <a:r>
                        <a:rPr lang="ja-JP" alt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</a:t>
                      </a:r>
                      <a:endParaRPr lang="en-US" altLang="ja-JP" sz="700" b="0" i="0" u="none" strike="noStrike" dirty="0">
                        <a:solidFill>
                          <a:schemeClr val="tx1"/>
                        </a:solidFill>
                        <a:effectLst/>
                        <a:latin typeface="Palatino Linotype" panose="02040502050505030304" pitchFamily="18" charset="0"/>
                        <a:ea typeface="游ゴシック" panose="020B0400000000000000" pitchFamily="50" charset="-128"/>
                      </a:endParaRPr>
                    </a:p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at an experimental plot in October</a:t>
                      </a:r>
                      <a:b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*For measuring </a:t>
                      </a: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Brix of growing sugarcane, the internode of a stalk is thrust and a drop of juice is collected by a specialized tool, such as a screwdriver with a pointed and dimpled tip. 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82038153"/>
                  </a:ext>
                </a:extLst>
              </a:tr>
              <a:tr h="328552">
                <a:tc v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ate of stalks with tassels and flag leaves</a:t>
                      </a:r>
                      <a:b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</a:br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 in sampled stalks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%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†</a:t>
                      </a:r>
                      <a:endParaRPr lang="ja-JP" altLang="en-US" sz="7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panose="02040502050505030304" pitchFamily="18" charset="0"/>
                        <a:ea typeface="+mn-ea"/>
                      </a:endParaRP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panose="02040502050505030304" pitchFamily="18" charset="0"/>
                          <a:ea typeface="+mn-ea"/>
                        </a:rPr>
                        <a:t>#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700" b="0" i="0" u="none" strike="noStrike" dirty="0">
                          <a:solidFill>
                            <a:schemeClr val="tx1"/>
                          </a:solidFill>
                          <a:effectLst/>
                          <a:latin typeface="Palatino Linotype" panose="02040502050505030304" pitchFamily="18" charset="0"/>
                          <a:ea typeface="游ゴシック" panose="020B0400000000000000" pitchFamily="50" charset="-128"/>
                        </a:rPr>
                        <a:t>Rate of heading or booting stalks to 10 sampled stalks in harvest season</a:t>
                      </a:r>
                    </a:p>
                  </a:txBody>
                  <a:tcPr marL="0" marR="0" marT="0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01415915"/>
                  </a:ext>
                </a:extLst>
              </a:tr>
            </a:tbl>
          </a:graphicData>
        </a:graphic>
      </p:graphicFrame>
      <mc:AlternateContent xmlns:mc="http://schemas.openxmlformats.org/markup-compatibility/2006" xmlns:a14="http://schemas.microsoft.com/office/drawing/2010/main">
        <mc:Choice Requires="a14">
          <p:sp>
            <p:nvSpPr>
              <p:cNvPr id="5" name="テキスト ボックス 1">
                <a:extLst>
                  <a:ext uri="{FF2B5EF4-FFF2-40B4-BE49-F238E27FC236}">
                    <a16:creationId xmlns:a16="http://schemas.microsoft.com/office/drawing/2014/main" id="{455CC3D8-7095-4CD0-AA6B-A326210C34C7}"/>
                  </a:ext>
                </a:extLst>
              </p:cNvPr>
              <p:cNvSpPr txBox="1"/>
              <p:nvPr/>
            </p:nvSpPr>
            <p:spPr>
              <a:xfrm>
                <a:off x="3035178" y="5261389"/>
                <a:ext cx="1425304" cy="334963"/>
              </a:xfrm>
              <a:prstGeom prst="rect">
                <a:avLst/>
              </a:prstGeom>
              <a:noFill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tx1"/>
              </a:fontRef>
            </p:style>
            <p:txBody>
              <a:bodyPr wrap="square" lIns="0" tIns="0" rIns="0" bIns="0" rtlCol="0" anchor="t">
                <a:spAutoFit/>
              </a:bodyPr>
              <a:lstStyle>
                <a:lvl1pPr marL="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kumimoji="1" lang="en-US" altLang="ja-JP" sz="700" b="0" i="1" dirty="0">
                    <a:solidFill>
                      <a:schemeClr val="tx1"/>
                    </a:solidFill>
                    <a:effectLst/>
                    <a:latin typeface="Palatino Linotype" panose="02040502050505030304" pitchFamily="18" charset="0"/>
                  </a:rPr>
                  <a:t>f</a:t>
                </a:r>
                <a14:m>
                  <m:oMath xmlns:m="http://schemas.openxmlformats.org/officeDocument/2006/math">
                    <m:r>
                      <a:rPr kumimoji="1" lang="en-US" altLang="ja-JP" sz="700" b="0" i="1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</a:rPr>
                      <m:t>𝑖𝑏𝑒𝑟</m:t>
                    </m:r>
                    <m:d>
                      <m:dPr>
                        <m:ctrlPr>
                          <a:rPr kumimoji="1" lang="en-US" altLang="ja-JP" sz="700" b="0" i="1">
                            <a:solidFill>
                              <a:schemeClr val="tx1"/>
                            </a:solidFill>
                            <a:effectLst/>
                            <a:latin typeface="Cambria Math" panose="02040503050406030204" pitchFamily="18" charset="0"/>
                          </a:rPr>
                        </m:ctrlPr>
                      </m:dPr>
                      <m:e>
                        <m:r>
                          <a:rPr kumimoji="1" lang="en-US" altLang="ja-JP" sz="700" b="0" i="1">
                            <a:solidFill>
                              <a:schemeClr val="tx1"/>
                            </a:solidFill>
                            <a:effectLst/>
                            <a:latin typeface="Cambria Math" panose="02040503050406030204" pitchFamily="18" charset="0"/>
                          </a:rPr>
                          <m:t>%</m:t>
                        </m:r>
                      </m:e>
                    </m:d>
                    <m:r>
                      <a:rPr kumimoji="1" lang="en-US" altLang="ja-JP" sz="700" b="0" i="1">
                        <a:solidFill>
                          <a:schemeClr val="tx1"/>
                        </a:solidFill>
                        <a:effectLst/>
                        <a:latin typeface="Cambria Math" panose="02040503050406030204" pitchFamily="18" charset="0"/>
                      </a:rPr>
                      <m:t>=</m:t>
                    </m:r>
                  </m:oMath>
                </a14:m>
                <a:endParaRPr kumimoji="1" lang="en-US" altLang="ja-JP" sz="700" b="0" i="1" dirty="0">
                  <a:solidFill>
                    <a:schemeClr val="tx1"/>
                  </a:solidFill>
                  <a:effectLst/>
                  <a:latin typeface="Palatino Linotype" panose="02040502050505030304" pitchFamily="18" charset="0"/>
                </a:endParaRPr>
              </a:p>
              <a:p>
                <a:pPr/>
                <a14:m>
                  <m:oMathPara xmlns:m="http://schemas.openxmlformats.org/officeDocument/2006/math">
                    <m:oMathParaPr>
                      <m:jc m:val="centerGroup"/>
                    </m:oMathParaPr>
                    <m:oMath xmlns:m="http://schemas.openxmlformats.org/officeDocument/2006/math">
                      <m:f>
                        <m:fPr>
                          <m:ctrlPr>
                            <a:rPr kumimoji="1" lang="en-US" altLang="ja-JP" sz="700" i="1">
                              <a:latin typeface="Cambria Math" panose="02040503050406030204" pitchFamily="18" charset="0"/>
                            </a:rPr>
                          </m:ctrlPr>
                        </m:fPr>
                        <m:num>
                          <m:sSub>
                            <m:sSubPr>
                              <m:ctrlPr>
                                <a:rPr kumimoji="1" lang="en-US" altLang="ja-JP" sz="700" b="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kumimoji="1" lang="en-US" altLang="ja-JP" sz="700" b="0" i="1">
                                  <a:latin typeface="Cambria Math" panose="02040503050406030204" pitchFamily="18" charset="0"/>
                                </a:rPr>
                                <m:t>𝑊</m:t>
                              </m:r>
                            </m:e>
                            <m:sub>
                              <m:r>
                                <a:rPr kumimoji="1" lang="en-US" altLang="ja-JP" sz="700" b="0" i="1">
                                  <a:solidFill>
                                    <a:schemeClr val="tx1"/>
                                  </a:solidFill>
                                  <a:effectLst/>
                                  <a:latin typeface="Cambria Math" panose="02040503050406030204" pitchFamily="18" charset="0"/>
                                </a:rPr>
                                <m:t>𝑑𝑟𝑦</m:t>
                              </m:r>
                            </m:sub>
                          </m:sSub>
                          <m:r>
                            <a:rPr kumimoji="1" lang="en-US" altLang="ja-JP" sz="700" b="0" i="1">
                              <a:solidFill>
                                <a:schemeClr val="tx1"/>
                              </a:solidFill>
                              <a:effectLst/>
                              <a:latin typeface="Cambria Math" panose="02040503050406030204" pitchFamily="18" charset="0"/>
                            </a:rPr>
                            <m:t>−</m:t>
                          </m:r>
                          <m:r>
                            <a:rPr kumimoji="1" lang="en-US" altLang="ja-JP" sz="700" b="0" i="1">
                              <a:solidFill>
                                <a:schemeClr val="tx1"/>
                              </a:solidFill>
                              <a:effectLst/>
                              <a:latin typeface="Cambria Math" panose="02040503050406030204" pitchFamily="18" charset="0"/>
                            </a:rPr>
                            <m:t>𝐵𝑟𝑖𝑥</m:t>
                          </m:r>
                          <m:r>
                            <a:rPr kumimoji="1" lang="en-US" altLang="ja-JP" sz="700" b="0" i="1">
                              <a:solidFill>
                                <a:schemeClr val="tx1"/>
                              </a:solidFill>
                              <a:effectLst/>
                              <a:latin typeface="Cambria Math" panose="02040503050406030204" pitchFamily="18" charset="0"/>
                            </a:rPr>
                            <m:t>×(</m:t>
                          </m:r>
                          <m:sSub>
                            <m:sSubPr>
                              <m:ctrlPr>
                                <a:rPr kumimoji="1" lang="en-US" altLang="ja-JP" sz="700" b="0" i="1">
                                  <a:solidFill>
                                    <a:schemeClr val="tx1"/>
                                  </a:solidFill>
                                  <a:effectLst/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sSub>
                                <m:sSubPr>
                                  <m:ctrlPr>
                                    <a:rPr kumimoji="1" lang="en-US" altLang="ja-JP" sz="700" b="0" i="1">
                                      <a:solidFill>
                                        <a:schemeClr val="tx1"/>
                                      </a:solidFill>
                                      <a:effectLst/>
                                      <a:latin typeface="Cambria Math" panose="02040503050406030204" pitchFamily="18" charset="0"/>
                                    </a:rPr>
                                  </m:ctrlPr>
                                </m:sSubPr>
                                <m:e>
                                  <m:r>
                                    <a:rPr kumimoji="1" lang="en-US" altLang="ja-JP" sz="700" b="0" i="1">
                                      <a:solidFill>
                                        <a:schemeClr val="tx1"/>
                                      </a:solidFill>
                                      <a:effectLst/>
                                      <a:latin typeface="Cambria Math" panose="02040503050406030204" pitchFamily="18" charset="0"/>
                                    </a:rPr>
                                    <m:t>𝑊</m:t>
                                  </m:r>
                                </m:e>
                                <m:sub>
                                  <m:r>
                                    <a:rPr kumimoji="1" lang="en-US" altLang="ja-JP" sz="700" b="0" i="1">
                                      <a:solidFill>
                                        <a:schemeClr val="tx1"/>
                                      </a:solidFill>
                                      <a:effectLst/>
                                      <a:latin typeface="Cambria Math" panose="02040503050406030204" pitchFamily="18" charset="0"/>
                                    </a:rPr>
                                    <m:t>𝑤𝑒𝑡</m:t>
                                  </m:r>
                                </m:sub>
                              </m:sSub>
                              <m:r>
                                <a:rPr kumimoji="1" lang="en-US" altLang="ja-JP" sz="700" b="0" i="1" smtClean="0">
                                  <a:solidFill>
                                    <a:schemeClr val="tx1"/>
                                  </a:solidFill>
                                  <a:effectLst/>
                                  <a:latin typeface="Cambria Math" panose="02040503050406030204" pitchFamily="18" charset="0"/>
                                </a:rPr>
                                <m:t>−</m:t>
                              </m:r>
                              <m:r>
                                <a:rPr kumimoji="1" lang="en-US" altLang="ja-JP" sz="700" b="0" i="1">
                                  <a:solidFill>
                                    <a:schemeClr val="tx1"/>
                                  </a:solidFill>
                                  <a:effectLst/>
                                  <a:latin typeface="Cambria Math" panose="02040503050406030204" pitchFamily="18" charset="0"/>
                                </a:rPr>
                                <m:t>𝑊</m:t>
                              </m:r>
                            </m:e>
                            <m:sub>
                              <m:r>
                                <a:rPr kumimoji="1" lang="en-US" altLang="ja-JP" sz="700" b="0" i="1">
                                  <a:solidFill>
                                    <a:schemeClr val="tx1"/>
                                  </a:solidFill>
                                  <a:effectLst/>
                                  <a:latin typeface="Cambria Math" panose="02040503050406030204" pitchFamily="18" charset="0"/>
                                </a:rPr>
                                <m:t>𝑑𝑟𝑦</m:t>
                              </m:r>
                            </m:sub>
                          </m:sSub>
                          <m:r>
                            <a:rPr kumimoji="1" lang="en-US" altLang="ja-JP" sz="700" b="0" i="1">
                              <a:solidFill>
                                <a:schemeClr val="tx1"/>
                              </a:solidFill>
                              <a:effectLst/>
                              <a:latin typeface="Cambria Math" panose="02040503050406030204" pitchFamily="18" charset="0"/>
                            </a:rPr>
                            <m:t>)</m:t>
                          </m:r>
                        </m:num>
                        <m:den>
                          <m:sSub>
                            <m:sSubPr>
                              <m:ctrlPr>
                                <a:rPr kumimoji="1" lang="en-US" altLang="ja-JP" sz="700" i="1">
                                  <a:latin typeface="Cambria Math" panose="02040503050406030204" pitchFamily="18" charset="0"/>
                                </a:rPr>
                              </m:ctrlPr>
                            </m:sSubPr>
                            <m:e>
                              <m:r>
                                <a:rPr kumimoji="1" lang="en-US" altLang="ja-JP" sz="700" b="0" i="1">
                                  <a:latin typeface="Cambria Math" panose="02040503050406030204" pitchFamily="18" charset="0"/>
                                </a:rPr>
                                <m:t>𝑊</m:t>
                              </m:r>
                            </m:e>
                            <m:sub>
                              <m:r>
                                <a:rPr kumimoji="1" lang="en-US" altLang="ja-JP" sz="700" b="0" i="1">
                                  <a:latin typeface="Cambria Math" panose="02040503050406030204" pitchFamily="18" charset="0"/>
                                </a:rPr>
                                <m:t>𝑐𝑎𝑛𝑒</m:t>
                              </m:r>
                            </m:sub>
                          </m:sSub>
                          <m:r>
                            <a:rPr kumimoji="1" lang="en-US" altLang="ja-JP" sz="700" b="0" i="1">
                              <a:latin typeface="Cambria Math" panose="02040503050406030204" pitchFamily="18" charset="0"/>
                              <a:ea typeface="Cambria Math" panose="02040503050406030204" pitchFamily="18" charset="0"/>
                            </a:rPr>
                            <m:t>×</m:t>
                          </m:r>
                          <m:r>
                            <a:rPr kumimoji="1" lang="en-US" altLang="ja-JP" sz="700" b="0" i="1">
                              <a:latin typeface="Cambria Math" panose="02040503050406030204" pitchFamily="18" charset="0"/>
                            </a:rPr>
                            <m:t>(100−</m:t>
                          </m:r>
                          <m:r>
                            <a:rPr kumimoji="1" lang="en-US" altLang="ja-JP" sz="700" b="0" i="1">
                              <a:latin typeface="Cambria Math" panose="02040503050406030204" pitchFamily="18" charset="0"/>
                            </a:rPr>
                            <m:t>𝐵𝑟𝑖𝑥</m:t>
                          </m:r>
                          <m:r>
                            <a:rPr kumimoji="1" lang="en-US" altLang="ja-JP" sz="700" b="0" i="1">
                              <a:latin typeface="Cambria Math" panose="02040503050406030204" pitchFamily="18" charset="0"/>
                            </a:rPr>
                            <m:t>)</m:t>
                          </m:r>
                        </m:den>
                      </m:f>
                      <m:r>
                        <a:rPr kumimoji="1" lang="en-US" altLang="ja-JP" sz="700" i="1" smtClean="0"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×</m:t>
                      </m:r>
                      <m:r>
                        <a:rPr kumimoji="1" lang="en-US" altLang="ja-JP" sz="700" b="0" i="1">
                          <a:latin typeface="Cambria Math" panose="02040503050406030204" pitchFamily="18" charset="0"/>
                          <a:ea typeface="Cambria Math" panose="02040503050406030204" pitchFamily="18" charset="0"/>
                        </a:rPr>
                        <m:t>100 </m:t>
                      </m:r>
                    </m:oMath>
                  </m:oMathPara>
                </a14:m>
                <a:endParaRPr kumimoji="1" lang="ja-JP" altLang="en-US" sz="700" dirty="0">
                  <a:latin typeface="Palatino Linotype" panose="02040502050505030304" pitchFamily="18" charset="0"/>
                </a:endParaRPr>
              </a:p>
            </p:txBody>
          </p:sp>
        </mc:Choice>
        <mc:Fallback xmlns="">
          <p:sp>
            <p:nvSpPr>
              <p:cNvPr id="5" name="テキスト ボックス 1">
                <a:extLst>
                  <a:ext uri="{FF2B5EF4-FFF2-40B4-BE49-F238E27FC236}">
                    <a16:creationId xmlns:a16="http://schemas.microsoft.com/office/drawing/2014/main" id="{455CC3D8-7095-4CD0-AA6B-A326210C34C7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3035178" y="5261389"/>
                <a:ext cx="1425304" cy="334963"/>
              </a:xfrm>
              <a:prstGeom prst="rect">
                <a:avLst/>
              </a:prstGeom>
              <a:blipFill>
                <a:blip r:embed="rId3"/>
                <a:stretch>
                  <a:fillRect l="-4274" t="-9091" r="-427" b="-12727"/>
                </a:stretch>
              </a:blipFill>
            </p:spPr>
            <p:txBody>
              <a:bodyPr/>
              <a:lstStyle/>
              <a:p>
                <a:r>
                  <a:rPr lang="ja-JP" alt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879D655-B768-5FAF-8D0E-1E9AD41B2728}"/>
              </a:ext>
            </a:extLst>
          </p:cNvPr>
          <p:cNvSpPr txBox="1"/>
          <p:nvPr/>
        </p:nvSpPr>
        <p:spPr>
          <a:xfrm>
            <a:off x="1" y="12032"/>
            <a:ext cx="6858000" cy="10618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b="1" dirty="0">
                <a:latin typeface="Palatino Linotype" panose="02040502050505030304" pitchFamily="18" charset="0"/>
              </a:rPr>
              <a:t>Table S3.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Survey items of agronomic characteristics in sugarcane breeding programs [1–4]. Based 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on research standards and common customs</a:t>
            </a:r>
            <a:r>
              <a:rPr lang="en-US" altLang="ja-JP" sz="9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, we examined the agronomic characteristics of each cultivar or clone. The category 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shows time of examination</a:t>
            </a:r>
            <a:r>
              <a:rPr lang="en-US" altLang="ja-JP" sz="900" dirty="0">
                <a:latin typeface="Palatino Linotype" panose="02040502050505030304" pitchFamily="18" charset="0"/>
                <a:ea typeface="游ゴシック" panose="020B0400000000000000" pitchFamily="50" charset="-128"/>
              </a:rPr>
              <a:t> of </a:t>
            </a:r>
            <a:r>
              <a:rPr lang="en-US" altLang="ja-JP" sz="9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the item. “Investigation object” </a:t>
            </a:r>
            <a:r>
              <a:rPr lang="en-US" altLang="ja-JP" sz="900" dirty="0">
                <a:latin typeface="Palatino Linotype" panose="02040502050505030304" pitchFamily="18" charset="0"/>
                <a:ea typeface="游ゴシック" panose="020B0400000000000000" pitchFamily="50" charset="-128"/>
              </a:rPr>
              <a:t>shows</a:t>
            </a:r>
            <a:r>
              <a:rPr lang="en-US" altLang="ja-JP" sz="9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 how the value was calculated. Double dagger (‡) means the value was obtained from complete surveys in which all stalks </a:t>
            </a:r>
            <a:r>
              <a:rPr lang="en-US" altLang="ja-JP" sz="900" dirty="0">
                <a:solidFill>
                  <a:srgbClr val="000000"/>
                </a:solidFill>
                <a:latin typeface="Palatino Linotype" panose="02040502050505030304" pitchFamily="18" charset="0"/>
                <a:ea typeface="游ゴシック" panose="020B0400000000000000" pitchFamily="50" charset="-128"/>
              </a:rPr>
              <a:t>were</a:t>
            </a:r>
            <a:r>
              <a:rPr lang="en-US" altLang="ja-JP" sz="9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 harvested </a:t>
            </a:r>
            <a:r>
              <a:rPr lang="en-US" altLang="ja-JP" sz="900" dirty="0">
                <a:solidFill>
                  <a:srgbClr val="000000"/>
                </a:solidFill>
                <a:latin typeface="Palatino Linotype" panose="02040502050505030304" pitchFamily="18" charset="0"/>
                <a:ea typeface="游ゴシック" panose="020B0400000000000000" pitchFamily="50" charset="-128"/>
              </a:rPr>
              <a:t>from</a:t>
            </a:r>
            <a:r>
              <a:rPr lang="en-US" altLang="ja-JP" sz="9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 each experimental plot</a:t>
            </a:r>
            <a:r>
              <a:rPr lang="en-US" altLang="ja-JP" sz="900" dirty="0">
                <a:solidFill>
                  <a:srgbClr val="000000"/>
                </a:solidFill>
                <a:latin typeface="Palatino Linotype" panose="02040502050505030304" pitchFamily="18" charset="0"/>
                <a:ea typeface="游ゴシック" panose="020B0400000000000000" pitchFamily="50" charset="-128"/>
              </a:rPr>
              <a:t>. A dagger 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(†)</a:t>
            </a:r>
            <a:r>
              <a:rPr lang="en-US" altLang="ja-JP" sz="9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 implies the average value from the sampling survey in which 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measuring 10 or 6 millable stalks were measured as representative of the experimental plots, in the local yield evaluation test and the fourth selection, respectively. However, a dagger (†) in t</a:t>
            </a:r>
            <a:r>
              <a:rPr lang="en-US" altLang="ja-JP" sz="900" dirty="0">
                <a:latin typeface="Palatino Linotype" panose="02040502050505030304" pitchFamily="18" charset="0"/>
                <a:ea typeface="游ゴシック" panose="020B0400000000000000" pitchFamily="50" charset="-128"/>
              </a:rPr>
              <a:t>he g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rowth category </a:t>
            </a:r>
            <a:r>
              <a:rPr lang="en-US" altLang="ja-JP" sz="900" dirty="0">
                <a:latin typeface="Palatino Linotype" panose="02040502050505030304" pitchFamily="18" charset="0"/>
                <a:ea typeface="游ゴシック" panose="020B0400000000000000" pitchFamily="50" charset="-128"/>
              </a:rPr>
              <a:t>indicate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s 6 stalks were sampled. A hash</a:t>
            </a:r>
            <a:r>
              <a:rPr lang="ja-JP" altLang="en-US" sz="900" dirty="0">
                <a:latin typeface="Palatino Linotype" panose="02040502050505030304" pitchFamily="18" charset="0"/>
                <a:ea typeface="游ゴシック" panose="020B0400000000000000" pitchFamily="50" charset="-128"/>
              </a:rPr>
              <a:t> 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(</a:t>
            </a:r>
            <a:r>
              <a:rPr lang="en-US" altLang="ja-JP" sz="8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#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) </a:t>
            </a:r>
            <a:r>
              <a:rPr lang="en-US" altLang="ja-JP" sz="900" dirty="0">
                <a:latin typeface="Palatino Linotype" panose="02040502050505030304" pitchFamily="18" charset="0"/>
                <a:ea typeface="游ゴシック" panose="020B0400000000000000" pitchFamily="50" charset="-128"/>
              </a:rPr>
              <a:t>in </a:t>
            </a:r>
            <a:r>
              <a:rPr lang="en-US" altLang="ja-JP" sz="900" b="0" i="0" u="none" strike="noStrike" dirty="0"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"Exclusions by test” indicates that the parameter was not measured in the fourth selection.</a:t>
            </a:r>
            <a:endParaRPr kumimoji="1" lang="en-US" altLang="ja-JP" sz="900" dirty="0">
              <a:latin typeface="Palatino Linotype" panose="0204050205050503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0743D26-D52A-3F47-F068-BDCE99603DFD}"/>
              </a:ext>
            </a:extLst>
          </p:cNvPr>
          <p:cNvSpPr txBox="1"/>
          <p:nvPr/>
        </p:nvSpPr>
        <p:spPr>
          <a:xfrm>
            <a:off x="4324709" y="5223040"/>
            <a:ext cx="26770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36000" algn="l" fontAlgn="ctr"/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W</a:t>
            </a:r>
            <a:r>
              <a:rPr lang="en-US" altLang="ja-JP" sz="700" b="0" i="0" u="none" strike="noStrike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dry </a:t>
            </a:r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(g): weight of dried bagasse without a cloth bag,</a:t>
            </a:r>
          </a:p>
          <a:p>
            <a:pPr marL="36000" algn="l" fontAlgn="ctr"/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W</a:t>
            </a:r>
            <a:r>
              <a:rPr lang="en-US" altLang="ja-JP" sz="700" b="0" i="0" u="none" strike="noStrike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wet </a:t>
            </a:r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(g): weight of wet bagasse after compression, </a:t>
            </a:r>
            <a:b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</a:br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W</a:t>
            </a:r>
            <a:r>
              <a:rPr lang="en-US" altLang="ja-JP" sz="700" b="0" i="0" u="none" strike="noStrike" baseline="-250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cane </a:t>
            </a:r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(g): weight of shredded sugarcane before compression, </a:t>
            </a:r>
          </a:p>
          <a:p>
            <a:pPr marL="36000" algn="l" fontAlgn="ctr"/>
            <a:r>
              <a:rPr lang="en-US" altLang="ja-JP" sz="700" b="0" i="0" u="none" strike="noStrike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ゴシック" panose="020B0400000000000000" pitchFamily="50" charset="-128"/>
              </a:rPr>
              <a:t>Brix (%): Brix of sugarcane juice</a:t>
            </a:r>
          </a:p>
        </p:txBody>
      </p:sp>
    </p:spTree>
    <p:extLst>
      <p:ext uri="{BB962C8B-B14F-4D97-AF65-F5344CB8AC3E}">
        <p14:creationId xmlns:p14="http://schemas.microsoft.com/office/powerpoint/2010/main" val="16089661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60BBB77-4016-5E81-3027-A50831EBC369}"/>
              </a:ext>
            </a:extLst>
          </p:cNvPr>
          <p:cNvSpPr txBox="1"/>
          <p:nvPr/>
        </p:nvSpPr>
        <p:spPr>
          <a:xfrm>
            <a:off x="0" y="0"/>
            <a:ext cx="6858000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Palatino Linotype" panose="02040502050505030304" pitchFamily="18" charset="0"/>
              </a:rPr>
              <a:t>References</a:t>
            </a:r>
          </a:p>
          <a:p>
            <a:pPr marL="228600" indent="-228600">
              <a:buFont typeface="+mj-lt"/>
              <a:buAutoNum type="arabicPeriod"/>
            </a:pPr>
            <a:r>
              <a:rPr kumimoji="1" lang="en-US" altLang="ja-JP" sz="900" dirty="0">
                <a:latin typeface="Palatino Linotype" panose="02040502050505030304" pitchFamily="18" charset="0"/>
              </a:rPr>
              <a:t>Kyushu National Agricultural Experiment Station; Kagoshima Agricultural Experiment Station; Okinawa Prefectural Agricultural Experiment Station;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Kanmi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Shige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Shinkokai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(Sugar Crop Development Fund). </a:t>
            </a:r>
            <a:r>
              <a:rPr kumimoji="1" lang="en-US" altLang="ja-JP" sz="900" i="1" dirty="0" err="1">
                <a:latin typeface="Palatino Linotype" panose="02040502050505030304" pitchFamily="18" charset="0"/>
              </a:rPr>
              <a:t>Satoukibi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i="1" dirty="0" err="1">
                <a:latin typeface="Palatino Linotype" panose="02040502050505030304" pitchFamily="18" charset="0"/>
              </a:rPr>
              <a:t>ni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i="1" dirty="0" err="1">
                <a:latin typeface="Palatino Linotype" panose="02040502050505030304" pitchFamily="18" charset="0"/>
              </a:rPr>
              <a:t>kansuru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i="1" dirty="0" err="1">
                <a:latin typeface="Palatino Linotype" panose="02040502050505030304" pitchFamily="18" charset="0"/>
              </a:rPr>
              <a:t>chousa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i="1" dirty="0" err="1">
                <a:latin typeface="Palatino Linotype" panose="02040502050505030304" pitchFamily="18" charset="0"/>
              </a:rPr>
              <a:t>kijun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(Research standards of sugarcane 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[In Japanese, translated by the author of this article]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)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; Kyushu National Agricultural Experiment Station: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Koshi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, Japan, 1982; pp. 1–19, 22–25. (In Japanese)</a:t>
            </a:r>
          </a:p>
          <a:p>
            <a:pPr marL="228600" indent="-228600">
              <a:buFont typeface="+mj-lt"/>
              <a:buAutoNum type="arabicPeriod"/>
            </a:pPr>
            <a:r>
              <a:rPr kumimoji="1" lang="en-US" altLang="ja-JP" sz="900" dirty="0">
                <a:latin typeface="Palatino Linotype" panose="02040502050505030304" pitchFamily="18" charset="0"/>
              </a:rPr>
              <a:t>Plant Variety Protection Office, Intellectual Property Division, Export and International Bureau, Ministry of Agriculture, Forestry and Fisheries. Test guideline (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Saccharum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L.). Available online: http://www.hinshu2.maff.go.jp/info/sinsakijun/kijun/1554.pdf (accessed on 4 March 2024). (In Japanese).</a:t>
            </a:r>
          </a:p>
          <a:p>
            <a:pPr marL="228600" indent="-228600">
              <a:buFont typeface="+mj-lt"/>
              <a:buAutoNum type="arabicPeriod"/>
            </a:pPr>
            <a:r>
              <a:rPr kumimoji="1" lang="en-US" altLang="ja-JP" sz="900" dirty="0">
                <a:latin typeface="Palatino Linotype" panose="02040502050505030304" pitchFamily="18" charset="0"/>
              </a:rPr>
              <a:t>International Union for the Protection of New Varieties of Plants. 2023. Test Guidelines Sugarcane (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Saccharum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L.) (Revision). Available online: https://www.upov.int/edocs/mdocs/upov/en/twa_52/tg_186_2_proj_4.pdf (accessed on 11 March 2024)</a:t>
            </a:r>
          </a:p>
          <a:p>
            <a:pPr marL="228600" indent="-228600">
              <a:buFont typeface="+mj-lt"/>
              <a:buAutoNum type="arabicPeriod"/>
            </a:pPr>
            <a:r>
              <a:rPr kumimoji="1" lang="en-US" altLang="ja-JP" sz="900" dirty="0" err="1">
                <a:latin typeface="Palatino Linotype" panose="02040502050505030304" pitchFamily="18" charset="0"/>
              </a:rPr>
              <a:t>Terajima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, Y.; Sugimoto, A.;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Tippayawat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, A.;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Irei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, S.; Hayashi, H. Root distribution and </a:t>
            </a:r>
            <a:r>
              <a:rPr kumimoji="1" lang="en-US" altLang="ja-JP" sz="900" dirty="0" err="1">
                <a:latin typeface="Palatino Linotype" panose="02040502050505030304" pitchFamily="18" charset="0"/>
              </a:rPr>
              <a:t>fibre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composition of intergeneric F1 hybrid between sugarcane and 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E.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 </a:t>
            </a:r>
            <a:r>
              <a:rPr kumimoji="1" lang="en-US" altLang="ja-JP" sz="900" i="1" dirty="0" err="1">
                <a:latin typeface="Palatino Linotype" panose="02040502050505030304" pitchFamily="18" charset="0"/>
              </a:rPr>
              <a:t>arundinaceus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. 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Field Crops Res. </a:t>
            </a:r>
            <a:r>
              <a:rPr kumimoji="1" lang="en-US" altLang="ja-JP" sz="900" b="1" dirty="0">
                <a:latin typeface="Palatino Linotype" panose="02040502050505030304" pitchFamily="18" charset="0"/>
              </a:rPr>
              <a:t>2023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, </a:t>
            </a:r>
            <a:r>
              <a:rPr kumimoji="1" lang="en-US" altLang="ja-JP" sz="900" i="1" dirty="0">
                <a:latin typeface="Palatino Linotype" panose="02040502050505030304" pitchFamily="18" charset="0"/>
              </a:rPr>
              <a:t>297</a:t>
            </a:r>
            <a:r>
              <a:rPr kumimoji="1" lang="en-US" altLang="ja-JP" sz="900" dirty="0">
                <a:latin typeface="Palatino Linotype" panose="02040502050505030304" pitchFamily="18" charset="0"/>
              </a:rPr>
              <a:t>, 108920. DOI: 10.1016/j.fcr.2023.108920.</a:t>
            </a:r>
          </a:p>
        </p:txBody>
      </p:sp>
    </p:spTree>
    <p:extLst>
      <p:ext uri="{BB962C8B-B14F-4D97-AF65-F5344CB8AC3E}">
        <p14:creationId xmlns:p14="http://schemas.microsoft.com/office/powerpoint/2010/main" val="3885266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03</TotalTime>
  <Words>2078</Words>
  <Application>Microsoft Office PowerPoint</Application>
  <PresentationFormat>A4 210 x 297 mm</PresentationFormat>
  <Paragraphs>735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Cambria Math</vt:lpstr>
      <vt:lpstr>Palatino Linotype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石川　千秋</dc:creator>
  <cp:lastModifiedBy>石川　千秋</cp:lastModifiedBy>
  <cp:revision>14</cp:revision>
  <cp:lastPrinted>2024-01-31T01:12:12Z</cp:lastPrinted>
  <dcterms:created xsi:type="dcterms:W3CDTF">2023-04-11T07:31:37Z</dcterms:created>
  <dcterms:modified xsi:type="dcterms:W3CDTF">2024-04-20T11:04:19Z</dcterms:modified>
</cp:coreProperties>
</file>